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199313" cy="102600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F6E46-0B11-4A84-BD01-F694F1F0B3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64800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0360" y="5931720"/>
            <a:ext cx="64800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85D215-1047-4C9F-B9A5-48680E3D50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0360" y="593172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680640" y="593172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F7C350-B58C-4B2F-AFA0-5E9A3697602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51320" y="239400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742280" y="239400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0360" y="593172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51320" y="593172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742280" y="593172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F69467-6CA7-4BE0-A915-4446EDBB7A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0360" y="2394000"/>
            <a:ext cx="6480000" cy="6772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25D420-F49E-404D-9AF5-0FE4AEA3A1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648000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260EF0-A615-4008-8F2B-A4868315CB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6DFFD1-7CF2-4F05-9849-283A40CD61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CADCAA-2543-480F-8EE4-157B74A002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0360" y="410760"/>
            <a:ext cx="6480000" cy="7926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51F179-187F-4B6A-8C15-3F11EE9843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0360" y="593172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62C9BE-D391-4A93-BF6B-D160DDF34A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680640" y="593172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893484-3DB0-44E8-8EF1-1CE0160F37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0360" y="5931720"/>
            <a:ext cx="64800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BD4906-DDC6-46D5-BB21-8E532CF009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0360" y="2394000"/>
            <a:ext cx="648000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0000" y="9344160"/>
            <a:ext cx="1679400" cy="712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60600" y="9344160"/>
            <a:ext cx="2279520" cy="712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160600" y="9344160"/>
            <a:ext cx="1679400" cy="712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3D0BEE-3A6B-459A-85B9-A69C09B4FFB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15350" t="33557" r="29020" b="50102"/>
          <a:stretch/>
        </p:blipFill>
        <p:spPr>
          <a:xfrm>
            <a:off x="1390680" y="2235240"/>
            <a:ext cx="4005360" cy="16765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781200" y="4141800"/>
            <a:ext cx="6095880" cy="96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Presentation 1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︱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: a segregating maize ear with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vp5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mutant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kernels (white) and wild type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Vp5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kernels (yellow) and seeds. 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B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: Mature, uniform seeds of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vp5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and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Vp5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used in this study.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Bar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represents 0.5 cm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雨林木风</cp:lastModifiedBy>
  <dcterms:modified xsi:type="dcterms:W3CDTF">2014-10-20T02:30:05Z</dcterms:modified>
  <cp:revision>3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  <property fmtid="{D5CDD505-2E9C-101B-9397-08002B2CF9AE}" pid="6" name="Version">
    <vt:r8>1</vt:r8>
  </property>
</Properties>
</file>